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4" autoAdjust="0"/>
    <p:restoredTop sz="94660"/>
  </p:normalViewPr>
  <p:slideViewPr>
    <p:cSldViewPr snapToGrid="0">
      <p:cViewPr varScale="1">
        <p:scale>
          <a:sx n="60" d="100"/>
          <a:sy n="60" d="100"/>
        </p:scale>
        <p:origin x="12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40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0468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1218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970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8838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1829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549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657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2529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323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280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66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6391" y="1957229"/>
            <a:ext cx="6435568" cy="3295255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829340" y="1203176"/>
            <a:ext cx="77936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opes and yield values for </a:t>
            </a:r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amethasone butyrate propionate and betamethasone </a:t>
            </a:r>
            <a:r>
              <a:rPr kumimoji="1" lang="en-US" altLang="ja-JP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erate</a:t>
            </a:r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ream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mulations obtained from the 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readability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915054" y="5252484"/>
            <a:ext cx="7793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pe: Each value indicate the mean (n=3).</a:t>
            </a:r>
          </a:p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ield value: Each value indicate the </a:t>
            </a:r>
            <a:r>
              <a:rPr kumimoji="1"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±SD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=3)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0264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26</TotalTime>
  <Words>42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　佳久</dc:creator>
  <cp:lastModifiedBy>山本　佳久</cp:lastModifiedBy>
  <cp:revision>12</cp:revision>
  <dcterms:created xsi:type="dcterms:W3CDTF">2019-09-28T05:48:37Z</dcterms:created>
  <dcterms:modified xsi:type="dcterms:W3CDTF">2019-09-30T07:02:26Z</dcterms:modified>
</cp:coreProperties>
</file>